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2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48" d="100"/>
          <a:sy n="48" d="100"/>
        </p:scale>
        <p:origin x="2096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rmurillo\Documents\Cancer\Integrative%20medicine\Publicaci&#243;n%20nacional\Tables%20and%20figure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rmurillo\Documents\Cancer\Integrative%20medicine\Publicaci&#243;n%20nacional\Tables%20and%20figure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rmurillo\Documents\Cancer\Integrative%20medicine\Publicaci&#243;n%20nacional\Tables%20and%20figure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rmurillo\Documents\Cancer\Integrative%20medicine\Publicaci&#243;n%20nacional\Tables%20and%20figure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rmurillo\Documents\Cancer\Integrative%20medicine\Publicaci&#243;n%20nacional\Tables%20and%20figures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rmurillo\Documents\Cancer\Integrative%20medicine\Publicaci&#243;n%20nacional\Tables%20and%20figures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Foods</a:t>
            </a:r>
          </a:p>
        </c:rich>
      </c:tx>
      <c:layout>
        <c:manualLayout>
          <c:xMode val="edge"/>
          <c:yMode val="edge"/>
          <c:x val="3.6326334208223995E-2"/>
          <c:y val="3.233256351039261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s-CO"/>
        </a:p>
      </c:txPr>
    </c:title>
    <c:autoTitleDeleted val="0"/>
    <c:plotArea>
      <c:layout/>
      <c:barChart>
        <c:barDir val="bar"/>
        <c:grouping val="stacked"/>
        <c:varyColors val="0"/>
        <c:ser>
          <c:idx val="0"/>
          <c:order val="0"/>
          <c:tx>
            <c:strRef>
              <c:f>'Figure 1'!$C$2</c:f>
              <c:strCache>
                <c:ptCount val="1"/>
                <c:pt idx="0">
                  <c:v>Curative</c:v>
                </c:pt>
              </c:strCache>
            </c:strRef>
          </c:tx>
          <c:spPr>
            <a:solidFill>
              <a:schemeClr val="accent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Figure 1'!$B$3:$B$7</c:f>
              <c:strCache>
                <c:ptCount val="5"/>
                <c:pt idx="0">
                  <c:v>Soursop</c:v>
                </c:pt>
                <c:pt idx="1">
                  <c:v>Sour grape</c:v>
                </c:pt>
                <c:pt idx="2">
                  <c:v>Blackberry</c:v>
                </c:pt>
                <c:pt idx="3">
                  <c:v>Spinach</c:v>
                </c:pt>
                <c:pt idx="4">
                  <c:v>Blueberry</c:v>
                </c:pt>
              </c:strCache>
            </c:strRef>
          </c:cat>
          <c:val>
            <c:numRef>
              <c:f>'Figure 1'!$C$3:$C$7</c:f>
              <c:numCache>
                <c:formatCode>General</c:formatCode>
                <c:ptCount val="5"/>
                <c:pt idx="0">
                  <c:v>99</c:v>
                </c:pt>
                <c:pt idx="1">
                  <c:v>27</c:v>
                </c:pt>
                <c:pt idx="2">
                  <c:v>18</c:v>
                </c:pt>
                <c:pt idx="3">
                  <c:v>19</c:v>
                </c:pt>
                <c:pt idx="4">
                  <c:v>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7C8-4E42-93E3-387DA1DCBA24}"/>
            </c:ext>
          </c:extLst>
        </c:ser>
        <c:ser>
          <c:idx val="1"/>
          <c:order val="1"/>
          <c:tx>
            <c:strRef>
              <c:f>'Figure 1'!$D$2</c:f>
              <c:strCache>
                <c:ptCount val="1"/>
                <c:pt idx="0">
                  <c:v>Both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cat>
            <c:strRef>
              <c:f>'Figure 1'!$B$3:$B$7</c:f>
              <c:strCache>
                <c:ptCount val="5"/>
                <c:pt idx="0">
                  <c:v>Soursop</c:v>
                </c:pt>
                <c:pt idx="1">
                  <c:v>Sour grape</c:v>
                </c:pt>
                <c:pt idx="2">
                  <c:v>Blackberry</c:v>
                </c:pt>
                <c:pt idx="3">
                  <c:v>Spinach</c:v>
                </c:pt>
                <c:pt idx="4">
                  <c:v>Blueberry</c:v>
                </c:pt>
              </c:strCache>
            </c:strRef>
          </c:cat>
          <c:val>
            <c:numRef>
              <c:f>'Figure 1'!$D$3:$D$7</c:f>
              <c:numCache>
                <c:formatCode>General</c:formatCode>
                <c:ptCount val="5"/>
                <c:pt idx="0">
                  <c:v>79</c:v>
                </c:pt>
                <c:pt idx="1">
                  <c:v>41</c:v>
                </c:pt>
                <c:pt idx="2">
                  <c:v>28</c:v>
                </c:pt>
                <c:pt idx="3">
                  <c:v>20</c:v>
                </c:pt>
                <c:pt idx="4">
                  <c:v>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7C8-4E42-93E3-387DA1DCBA24}"/>
            </c:ext>
          </c:extLst>
        </c:ser>
        <c:ser>
          <c:idx val="2"/>
          <c:order val="2"/>
          <c:tx>
            <c:strRef>
              <c:f>'Figure 1'!$E$2</c:f>
              <c:strCache>
                <c:ptCount val="1"/>
                <c:pt idx="0">
                  <c:v>Palliative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strRef>
              <c:f>'Figure 1'!$B$3:$B$7</c:f>
              <c:strCache>
                <c:ptCount val="5"/>
                <c:pt idx="0">
                  <c:v>Soursop</c:v>
                </c:pt>
                <c:pt idx="1">
                  <c:v>Sour grape</c:v>
                </c:pt>
                <c:pt idx="2">
                  <c:v>Blackberry</c:v>
                </c:pt>
                <c:pt idx="3">
                  <c:v>Spinach</c:v>
                </c:pt>
                <c:pt idx="4">
                  <c:v>Blueberry</c:v>
                </c:pt>
              </c:strCache>
            </c:strRef>
          </c:cat>
          <c:val>
            <c:numRef>
              <c:f>'Figure 1'!$E$3:$E$7</c:f>
              <c:numCache>
                <c:formatCode>General</c:formatCode>
                <c:ptCount val="5"/>
                <c:pt idx="0">
                  <c:v>115</c:v>
                </c:pt>
                <c:pt idx="1">
                  <c:v>75</c:v>
                </c:pt>
                <c:pt idx="2">
                  <c:v>71</c:v>
                </c:pt>
                <c:pt idx="3">
                  <c:v>56</c:v>
                </c:pt>
                <c:pt idx="4">
                  <c:v>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7C8-4E42-93E3-387DA1DCBA2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59567472"/>
        <c:axId val="79227136"/>
      </c:barChart>
      <c:catAx>
        <c:axId val="2059567472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CO"/>
          </a:p>
        </c:txPr>
        <c:crossAx val="79227136"/>
        <c:crosses val="autoZero"/>
        <c:auto val="1"/>
        <c:lblAlgn val="ctr"/>
        <c:lblOffset val="100"/>
        <c:noMultiLvlLbl val="0"/>
      </c:catAx>
      <c:valAx>
        <c:axId val="79227136"/>
        <c:scaling>
          <c:orientation val="minMax"/>
          <c:max val="30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prstDash val="sysDot"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CO"/>
          </a:p>
        </c:txPr>
        <c:crossAx val="2059567472"/>
        <c:crosses val="max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s-CO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bg1">
          <a:lumMod val="75000"/>
        </a:schemeClr>
      </a:solidFill>
    </a:ln>
    <a:effectLst/>
  </c:spPr>
  <c:txPr>
    <a:bodyPr/>
    <a:lstStyle/>
    <a:p>
      <a:pPr>
        <a:defRPr/>
      </a:pPr>
      <a:endParaRPr lang="es-CO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Herbal products</a:t>
            </a:r>
          </a:p>
        </c:rich>
      </c:tx>
      <c:layout>
        <c:manualLayout>
          <c:xMode val="edge"/>
          <c:yMode val="edge"/>
          <c:x val="3.4767413268344906E-2"/>
          <c:y val="3.712296983758700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s-CO"/>
        </a:p>
      </c:txPr>
    </c:title>
    <c:autoTitleDeleted val="0"/>
    <c:plotArea>
      <c:layout/>
      <c:barChart>
        <c:barDir val="bar"/>
        <c:grouping val="stacked"/>
        <c:varyColors val="0"/>
        <c:ser>
          <c:idx val="0"/>
          <c:order val="0"/>
          <c:tx>
            <c:strRef>
              <c:f>'Figure 1'!$I$2</c:f>
              <c:strCache>
                <c:ptCount val="1"/>
                <c:pt idx="0">
                  <c:v>Curative</c:v>
                </c:pt>
              </c:strCache>
            </c:strRef>
          </c:tx>
          <c:spPr>
            <a:solidFill>
              <a:schemeClr val="accent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Figure 1'!$H$3:$H$7</c:f>
              <c:strCache>
                <c:ptCount val="5"/>
                <c:pt idx="0">
                  <c:v>Anamu</c:v>
                </c:pt>
                <c:pt idx="1">
                  <c:v>Soursop leaves</c:v>
                </c:pt>
                <c:pt idx="2">
                  <c:v>Chamomile</c:v>
                </c:pt>
                <c:pt idx="3">
                  <c:v>Peppermint</c:v>
                </c:pt>
                <c:pt idx="4">
                  <c:v>Calendula</c:v>
                </c:pt>
              </c:strCache>
            </c:strRef>
          </c:cat>
          <c:val>
            <c:numRef>
              <c:f>'Figure 1'!$I$3:$I$7</c:f>
              <c:numCache>
                <c:formatCode>General</c:formatCode>
                <c:ptCount val="5"/>
                <c:pt idx="0">
                  <c:v>47</c:v>
                </c:pt>
                <c:pt idx="1">
                  <c:v>46</c:v>
                </c:pt>
                <c:pt idx="2">
                  <c:v>10</c:v>
                </c:pt>
                <c:pt idx="3">
                  <c:v>5</c:v>
                </c:pt>
                <c:pt idx="4">
                  <c:v>1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B4F-4717-9C0F-DC82E9FDEDBF}"/>
            </c:ext>
          </c:extLst>
        </c:ser>
        <c:ser>
          <c:idx val="1"/>
          <c:order val="1"/>
          <c:tx>
            <c:strRef>
              <c:f>'Figure 1'!$J$2</c:f>
              <c:strCache>
                <c:ptCount val="1"/>
                <c:pt idx="0">
                  <c:v>Both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cat>
            <c:strRef>
              <c:f>'Figure 1'!$H$3:$H$7</c:f>
              <c:strCache>
                <c:ptCount val="5"/>
                <c:pt idx="0">
                  <c:v>Anamu</c:v>
                </c:pt>
                <c:pt idx="1">
                  <c:v>Soursop leaves</c:v>
                </c:pt>
                <c:pt idx="2">
                  <c:v>Chamomile</c:v>
                </c:pt>
                <c:pt idx="3">
                  <c:v>Peppermint</c:v>
                </c:pt>
                <c:pt idx="4">
                  <c:v>Calendula</c:v>
                </c:pt>
              </c:strCache>
            </c:strRef>
          </c:cat>
          <c:val>
            <c:numRef>
              <c:f>'Figure 1'!$J$3:$J$7</c:f>
              <c:numCache>
                <c:formatCode>General</c:formatCode>
                <c:ptCount val="5"/>
                <c:pt idx="0">
                  <c:v>51</c:v>
                </c:pt>
                <c:pt idx="1">
                  <c:v>51</c:v>
                </c:pt>
                <c:pt idx="2">
                  <c:v>29</c:v>
                </c:pt>
                <c:pt idx="3">
                  <c:v>14</c:v>
                </c:pt>
                <c:pt idx="4">
                  <c:v>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B4F-4717-9C0F-DC82E9FDEDBF}"/>
            </c:ext>
          </c:extLst>
        </c:ser>
        <c:ser>
          <c:idx val="2"/>
          <c:order val="2"/>
          <c:tx>
            <c:strRef>
              <c:f>'Figure 1'!$K$2</c:f>
              <c:strCache>
                <c:ptCount val="1"/>
                <c:pt idx="0">
                  <c:v>Palliative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strRef>
              <c:f>'Figure 1'!$H$3:$H$7</c:f>
              <c:strCache>
                <c:ptCount val="5"/>
                <c:pt idx="0">
                  <c:v>Anamu</c:v>
                </c:pt>
                <c:pt idx="1">
                  <c:v>Soursop leaves</c:v>
                </c:pt>
                <c:pt idx="2">
                  <c:v>Chamomile</c:v>
                </c:pt>
                <c:pt idx="3">
                  <c:v>Peppermint</c:v>
                </c:pt>
                <c:pt idx="4">
                  <c:v>Calendula</c:v>
                </c:pt>
              </c:strCache>
            </c:strRef>
          </c:cat>
          <c:val>
            <c:numRef>
              <c:f>'Figure 1'!$K$3:$K$7</c:f>
              <c:numCache>
                <c:formatCode>General</c:formatCode>
                <c:ptCount val="5"/>
                <c:pt idx="0">
                  <c:v>58</c:v>
                </c:pt>
                <c:pt idx="1">
                  <c:v>46</c:v>
                </c:pt>
                <c:pt idx="2">
                  <c:v>84</c:v>
                </c:pt>
                <c:pt idx="3">
                  <c:v>37</c:v>
                </c:pt>
                <c:pt idx="4">
                  <c:v>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B4F-4717-9C0F-DC82E9FDEDB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0122704"/>
        <c:axId val="1945320288"/>
      </c:barChart>
      <c:catAx>
        <c:axId val="200122704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CO"/>
          </a:p>
        </c:txPr>
        <c:crossAx val="1945320288"/>
        <c:crosses val="autoZero"/>
        <c:auto val="1"/>
        <c:lblAlgn val="ctr"/>
        <c:lblOffset val="100"/>
        <c:noMultiLvlLbl val="0"/>
      </c:catAx>
      <c:valAx>
        <c:axId val="1945320288"/>
        <c:scaling>
          <c:orientation val="minMax"/>
          <c:max val="30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prstDash val="sysDot"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CO"/>
          </a:p>
        </c:txPr>
        <c:crossAx val="200122704"/>
        <c:crosses val="max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s-CO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bg1">
          <a:lumMod val="75000"/>
        </a:schemeClr>
      </a:solidFill>
    </a:ln>
    <a:effectLst/>
  </c:spPr>
  <c:txPr>
    <a:bodyPr/>
    <a:lstStyle/>
    <a:p>
      <a:pPr>
        <a:defRPr/>
      </a:pPr>
      <a:endParaRPr lang="es-CO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s-CO"/>
              <a:t>Diet</a:t>
            </a:r>
            <a:r>
              <a:rPr lang="es-CO" baseline="0"/>
              <a:t> regimens</a:t>
            </a:r>
          </a:p>
        </c:rich>
      </c:tx>
      <c:layout>
        <c:manualLayout>
          <c:xMode val="edge"/>
          <c:yMode val="edge"/>
          <c:x val="3.5017239777713413E-2"/>
          <c:y val="3.712296983758700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s-CO"/>
        </a:p>
      </c:txPr>
    </c:title>
    <c:autoTitleDeleted val="0"/>
    <c:plotArea>
      <c:layout/>
      <c:barChart>
        <c:barDir val="bar"/>
        <c:grouping val="stacked"/>
        <c:varyColors val="0"/>
        <c:ser>
          <c:idx val="0"/>
          <c:order val="0"/>
          <c:tx>
            <c:strRef>
              <c:f>'Figure 1'!$C$10</c:f>
              <c:strCache>
                <c:ptCount val="1"/>
                <c:pt idx="0">
                  <c:v>Curative</c:v>
                </c:pt>
              </c:strCache>
            </c:strRef>
          </c:tx>
          <c:spPr>
            <a:solidFill>
              <a:schemeClr val="accent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Figure 1'!$B$11:$B$15</c:f>
              <c:strCache>
                <c:ptCount val="5"/>
                <c:pt idx="0">
                  <c:v>Red meat restriction</c:v>
                </c:pt>
                <c:pt idx="1">
                  <c:v>Sugar restriction</c:v>
                </c:pt>
                <c:pt idx="2">
                  <c:v>Diary restriction</c:v>
                </c:pt>
                <c:pt idx="3">
                  <c:v>Increased F&amp;V</c:v>
                </c:pt>
                <c:pt idx="4">
                  <c:v>Sausage restriction</c:v>
                </c:pt>
              </c:strCache>
            </c:strRef>
          </c:cat>
          <c:val>
            <c:numRef>
              <c:f>'Figure 1'!$C$11:$C$15</c:f>
              <c:numCache>
                <c:formatCode>General</c:formatCode>
                <c:ptCount val="5"/>
                <c:pt idx="0">
                  <c:v>22</c:v>
                </c:pt>
                <c:pt idx="1">
                  <c:v>13</c:v>
                </c:pt>
                <c:pt idx="2">
                  <c:v>14</c:v>
                </c:pt>
                <c:pt idx="3">
                  <c:v>11</c:v>
                </c:pt>
                <c:pt idx="4">
                  <c:v>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774-47CC-A422-AB1BCE57532E}"/>
            </c:ext>
          </c:extLst>
        </c:ser>
        <c:ser>
          <c:idx val="1"/>
          <c:order val="1"/>
          <c:tx>
            <c:strRef>
              <c:f>'Figure 1'!$D$10</c:f>
              <c:strCache>
                <c:ptCount val="1"/>
                <c:pt idx="0">
                  <c:v>Both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cat>
            <c:strRef>
              <c:f>'Figure 1'!$B$11:$B$15</c:f>
              <c:strCache>
                <c:ptCount val="5"/>
                <c:pt idx="0">
                  <c:v>Red meat restriction</c:v>
                </c:pt>
                <c:pt idx="1">
                  <c:v>Sugar restriction</c:v>
                </c:pt>
                <c:pt idx="2">
                  <c:v>Diary restriction</c:v>
                </c:pt>
                <c:pt idx="3">
                  <c:v>Increased F&amp;V</c:v>
                </c:pt>
                <c:pt idx="4">
                  <c:v>Sausage restriction</c:v>
                </c:pt>
              </c:strCache>
            </c:strRef>
          </c:cat>
          <c:val>
            <c:numRef>
              <c:f>'Figure 1'!$D$11:$D$15</c:f>
              <c:numCache>
                <c:formatCode>General</c:formatCode>
                <c:ptCount val="5"/>
                <c:pt idx="0">
                  <c:v>19</c:v>
                </c:pt>
                <c:pt idx="1">
                  <c:v>17</c:v>
                </c:pt>
                <c:pt idx="2">
                  <c:v>7</c:v>
                </c:pt>
                <c:pt idx="3">
                  <c:v>13</c:v>
                </c:pt>
                <c:pt idx="4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774-47CC-A422-AB1BCE57532E}"/>
            </c:ext>
          </c:extLst>
        </c:ser>
        <c:ser>
          <c:idx val="2"/>
          <c:order val="2"/>
          <c:tx>
            <c:strRef>
              <c:f>'Figure 1'!$E$10</c:f>
              <c:strCache>
                <c:ptCount val="1"/>
                <c:pt idx="0">
                  <c:v>Palliative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strRef>
              <c:f>'Figure 1'!$B$11:$B$15</c:f>
              <c:strCache>
                <c:ptCount val="5"/>
                <c:pt idx="0">
                  <c:v>Red meat restriction</c:v>
                </c:pt>
                <c:pt idx="1">
                  <c:v>Sugar restriction</c:v>
                </c:pt>
                <c:pt idx="2">
                  <c:v>Diary restriction</c:v>
                </c:pt>
                <c:pt idx="3">
                  <c:v>Increased F&amp;V</c:v>
                </c:pt>
                <c:pt idx="4">
                  <c:v>Sausage restriction</c:v>
                </c:pt>
              </c:strCache>
            </c:strRef>
          </c:cat>
          <c:val>
            <c:numRef>
              <c:f>'Figure 1'!$E$11:$E$15</c:f>
              <c:numCache>
                <c:formatCode>General</c:formatCode>
                <c:ptCount val="5"/>
                <c:pt idx="0">
                  <c:v>28</c:v>
                </c:pt>
                <c:pt idx="1">
                  <c:v>14</c:v>
                </c:pt>
                <c:pt idx="2">
                  <c:v>20</c:v>
                </c:pt>
                <c:pt idx="3">
                  <c:v>18</c:v>
                </c:pt>
                <c:pt idx="4">
                  <c:v>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774-47CC-A422-AB1BCE57532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858209744"/>
        <c:axId val="79229216"/>
      </c:barChart>
      <c:catAx>
        <c:axId val="1858209744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CO"/>
          </a:p>
        </c:txPr>
        <c:crossAx val="79229216"/>
        <c:crosses val="autoZero"/>
        <c:auto val="1"/>
        <c:lblAlgn val="ctr"/>
        <c:lblOffset val="100"/>
        <c:noMultiLvlLbl val="0"/>
      </c:catAx>
      <c:valAx>
        <c:axId val="79229216"/>
        <c:scaling>
          <c:orientation val="minMax"/>
          <c:max val="30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prstDash val="sysDot"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CO"/>
          </a:p>
        </c:txPr>
        <c:crossAx val="1858209744"/>
        <c:crosses val="max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s-CO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bg1">
          <a:lumMod val="75000"/>
        </a:schemeClr>
      </a:solidFill>
    </a:ln>
    <a:effectLst/>
  </c:spPr>
  <c:txPr>
    <a:bodyPr/>
    <a:lstStyle/>
    <a:p>
      <a:pPr>
        <a:defRPr/>
      </a:pPr>
      <a:endParaRPr lang="es-CO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Animal products</a:t>
            </a:r>
          </a:p>
        </c:rich>
      </c:tx>
      <c:layout>
        <c:manualLayout>
          <c:xMode val="edge"/>
          <c:yMode val="edge"/>
          <c:x val="3.2088827203331026E-2"/>
          <c:y val="3.24825986078886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s-CO"/>
        </a:p>
      </c:txPr>
    </c:title>
    <c:autoTitleDeleted val="0"/>
    <c:plotArea>
      <c:layout/>
      <c:barChart>
        <c:barDir val="bar"/>
        <c:grouping val="stacked"/>
        <c:varyColors val="0"/>
        <c:ser>
          <c:idx val="0"/>
          <c:order val="0"/>
          <c:tx>
            <c:strRef>
              <c:f>'Figure 1'!$I$10</c:f>
              <c:strCache>
                <c:ptCount val="1"/>
                <c:pt idx="0">
                  <c:v>Curative</c:v>
                </c:pt>
              </c:strCache>
            </c:strRef>
          </c:tx>
          <c:spPr>
            <a:solidFill>
              <a:schemeClr val="accent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Figure 1'!$H$11:$H$15</c:f>
              <c:strCache>
                <c:ptCount val="5"/>
                <c:pt idx="0">
                  <c:v>Chicken shanks</c:v>
                </c:pt>
                <c:pt idx="1">
                  <c:v>Snake</c:v>
                </c:pt>
                <c:pt idx="2">
                  <c:v>Fish products</c:v>
                </c:pt>
                <c:pt idx="3">
                  <c:v>Black vulture</c:v>
                </c:pt>
                <c:pt idx="4">
                  <c:v>Cow liver</c:v>
                </c:pt>
              </c:strCache>
            </c:strRef>
          </c:cat>
          <c:val>
            <c:numRef>
              <c:f>'Figure 1'!$I$11:$I$15</c:f>
              <c:numCache>
                <c:formatCode>General</c:formatCode>
                <c:ptCount val="5"/>
                <c:pt idx="0">
                  <c:v>28</c:v>
                </c:pt>
                <c:pt idx="1">
                  <c:v>26</c:v>
                </c:pt>
                <c:pt idx="2">
                  <c:v>8</c:v>
                </c:pt>
                <c:pt idx="3">
                  <c:v>7</c:v>
                </c:pt>
                <c:pt idx="4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C69-418D-92E1-15CA39F3BEDD}"/>
            </c:ext>
          </c:extLst>
        </c:ser>
        <c:ser>
          <c:idx val="1"/>
          <c:order val="1"/>
          <c:tx>
            <c:strRef>
              <c:f>'Figure 1'!$J$10</c:f>
              <c:strCache>
                <c:ptCount val="1"/>
                <c:pt idx="0">
                  <c:v>Both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cat>
            <c:strRef>
              <c:f>'Figure 1'!$H$11:$H$15</c:f>
              <c:strCache>
                <c:ptCount val="5"/>
                <c:pt idx="0">
                  <c:v>Chicken shanks</c:v>
                </c:pt>
                <c:pt idx="1">
                  <c:v>Snake</c:v>
                </c:pt>
                <c:pt idx="2">
                  <c:v>Fish products</c:v>
                </c:pt>
                <c:pt idx="3">
                  <c:v>Black vulture</c:v>
                </c:pt>
                <c:pt idx="4">
                  <c:v>Cow liver</c:v>
                </c:pt>
              </c:strCache>
            </c:strRef>
          </c:cat>
          <c:val>
            <c:numRef>
              <c:f>'Figure 1'!$J$11:$J$15</c:f>
              <c:numCache>
                <c:formatCode>General</c:formatCode>
                <c:ptCount val="5"/>
                <c:pt idx="0">
                  <c:v>22</c:v>
                </c:pt>
                <c:pt idx="1">
                  <c:v>33</c:v>
                </c:pt>
                <c:pt idx="2">
                  <c:v>15</c:v>
                </c:pt>
                <c:pt idx="3">
                  <c:v>7</c:v>
                </c:pt>
                <c:pt idx="4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C69-418D-92E1-15CA39F3BEDD}"/>
            </c:ext>
          </c:extLst>
        </c:ser>
        <c:ser>
          <c:idx val="2"/>
          <c:order val="2"/>
          <c:tx>
            <c:strRef>
              <c:f>'Figure 1'!$K$10</c:f>
              <c:strCache>
                <c:ptCount val="1"/>
                <c:pt idx="0">
                  <c:v>Palliative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strRef>
              <c:f>'Figure 1'!$H$11:$H$15</c:f>
              <c:strCache>
                <c:ptCount val="5"/>
                <c:pt idx="0">
                  <c:v>Chicken shanks</c:v>
                </c:pt>
                <c:pt idx="1">
                  <c:v>Snake</c:v>
                </c:pt>
                <c:pt idx="2">
                  <c:v>Fish products</c:v>
                </c:pt>
                <c:pt idx="3">
                  <c:v>Black vulture</c:v>
                </c:pt>
                <c:pt idx="4">
                  <c:v>Cow liver</c:v>
                </c:pt>
              </c:strCache>
            </c:strRef>
          </c:cat>
          <c:val>
            <c:numRef>
              <c:f>'Figure 1'!$K$11:$K$15</c:f>
              <c:numCache>
                <c:formatCode>General</c:formatCode>
                <c:ptCount val="5"/>
                <c:pt idx="0">
                  <c:v>39</c:v>
                </c:pt>
                <c:pt idx="1">
                  <c:v>18</c:v>
                </c:pt>
                <c:pt idx="2">
                  <c:v>24</c:v>
                </c:pt>
                <c:pt idx="3">
                  <c:v>8</c:v>
                </c:pt>
                <c:pt idx="4">
                  <c:v>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C69-418D-92E1-15CA39F3BE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0117904"/>
        <c:axId val="1945327360"/>
      </c:barChart>
      <c:catAx>
        <c:axId val="200117904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CO"/>
          </a:p>
        </c:txPr>
        <c:crossAx val="1945327360"/>
        <c:crosses val="autoZero"/>
        <c:auto val="1"/>
        <c:lblAlgn val="ctr"/>
        <c:lblOffset val="100"/>
        <c:noMultiLvlLbl val="0"/>
      </c:catAx>
      <c:valAx>
        <c:axId val="1945327360"/>
        <c:scaling>
          <c:orientation val="minMax"/>
          <c:max val="30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prstDash val="sysDot"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CO"/>
          </a:p>
        </c:txPr>
        <c:crossAx val="200117904"/>
        <c:crosses val="max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s-CO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bg1">
          <a:lumMod val="75000"/>
        </a:schemeClr>
      </a:solidFill>
    </a:ln>
    <a:effectLst/>
  </c:spPr>
  <c:txPr>
    <a:bodyPr/>
    <a:lstStyle/>
    <a:p>
      <a:pPr>
        <a:defRPr/>
      </a:pPr>
      <a:endParaRPr lang="es-CO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Vitamins and commercial products</a:t>
            </a:r>
          </a:p>
        </c:rich>
      </c:tx>
      <c:layout>
        <c:manualLayout>
          <c:xMode val="edge"/>
          <c:yMode val="edge"/>
          <c:x val="3.2310895211658572E-2"/>
          <c:y val="3.712296983758700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s-CO"/>
        </a:p>
      </c:txPr>
    </c:title>
    <c:autoTitleDeleted val="0"/>
    <c:plotArea>
      <c:layout/>
      <c:barChart>
        <c:barDir val="bar"/>
        <c:grouping val="stacked"/>
        <c:varyColors val="0"/>
        <c:ser>
          <c:idx val="0"/>
          <c:order val="0"/>
          <c:tx>
            <c:strRef>
              <c:f>'Figure 1'!$C$18</c:f>
              <c:strCache>
                <c:ptCount val="1"/>
                <c:pt idx="0">
                  <c:v>Curative</c:v>
                </c:pt>
              </c:strCache>
            </c:strRef>
          </c:tx>
          <c:spPr>
            <a:solidFill>
              <a:schemeClr val="accent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Figure 1'!$B$19:$B$23</c:f>
              <c:strCache>
                <c:ptCount val="5"/>
                <c:pt idx="0">
                  <c:v>Transfer factor®</c:v>
                </c:pt>
                <c:pt idx="1">
                  <c:v>Vitamine C</c:v>
                </c:pt>
                <c:pt idx="2">
                  <c:v>Inmunocal®</c:v>
                </c:pt>
                <c:pt idx="3">
                  <c:v>Vitamine E</c:v>
                </c:pt>
                <c:pt idx="4">
                  <c:v>Vitamine D</c:v>
                </c:pt>
              </c:strCache>
            </c:strRef>
          </c:cat>
          <c:val>
            <c:numRef>
              <c:f>'Figure 1'!$C$19:$C$23</c:f>
              <c:numCache>
                <c:formatCode>General</c:formatCode>
                <c:ptCount val="5"/>
                <c:pt idx="0">
                  <c:v>27</c:v>
                </c:pt>
                <c:pt idx="1">
                  <c:v>16</c:v>
                </c:pt>
                <c:pt idx="2">
                  <c:v>20</c:v>
                </c:pt>
                <c:pt idx="3">
                  <c:v>10</c:v>
                </c:pt>
                <c:pt idx="4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B1C-489F-A44D-95E9D2F11388}"/>
            </c:ext>
          </c:extLst>
        </c:ser>
        <c:ser>
          <c:idx val="1"/>
          <c:order val="1"/>
          <c:tx>
            <c:strRef>
              <c:f>'Figure 1'!$D$18</c:f>
              <c:strCache>
                <c:ptCount val="1"/>
                <c:pt idx="0">
                  <c:v>Both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cat>
            <c:strRef>
              <c:f>'Figure 1'!$B$19:$B$23</c:f>
              <c:strCache>
                <c:ptCount val="5"/>
                <c:pt idx="0">
                  <c:v>Transfer factor®</c:v>
                </c:pt>
                <c:pt idx="1">
                  <c:v>Vitamine C</c:v>
                </c:pt>
                <c:pt idx="2">
                  <c:v>Inmunocal®</c:v>
                </c:pt>
                <c:pt idx="3">
                  <c:v>Vitamine E</c:v>
                </c:pt>
                <c:pt idx="4">
                  <c:v>Vitamine D</c:v>
                </c:pt>
              </c:strCache>
            </c:strRef>
          </c:cat>
          <c:val>
            <c:numRef>
              <c:f>'Figure 1'!$D$19:$D$23</c:f>
              <c:numCache>
                <c:formatCode>General</c:formatCode>
                <c:ptCount val="5"/>
                <c:pt idx="0">
                  <c:v>62</c:v>
                </c:pt>
                <c:pt idx="1">
                  <c:v>21</c:v>
                </c:pt>
                <c:pt idx="2">
                  <c:v>23</c:v>
                </c:pt>
                <c:pt idx="3">
                  <c:v>9</c:v>
                </c:pt>
                <c:pt idx="4">
                  <c:v>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B1C-489F-A44D-95E9D2F11388}"/>
            </c:ext>
          </c:extLst>
        </c:ser>
        <c:ser>
          <c:idx val="2"/>
          <c:order val="2"/>
          <c:tx>
            <c:strRef>
              <c:f>'Figure 1'!$E$18</c:f>
              <c:strCache>
                <c:ptCount val="1"/>
                <c:pt idx="0">
                  <c:v>Palliative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strRef>
              <c:f>'Figure 1'!$B$19:$B$23</c:f>
              <c:strCache>
                <c:ptCount val="5"/>
                <c:pt idx="0">
                  <c:v>Transfer factor®</c:v>
                </c:pt>
                <c:pt idx="1">
                  <c:v>Vitamine C</c:v>
                </c:pt>
                <c:pt idx="2">
                  <c:v>Inmunocal®</c:v>
                </c:pt>
                <c:pt idx="3">
                  <c:v>Vitamine E</c:v>
                </c:pt>
                <c:pt idx="4">
                  <c:v>Vitamine D</c:v>
                </c:pt>
              </c:strCache>
            </c:strRef>
          </c:cat>
          <c:val>
            <c:numRef>
              <c:f>'Figure 1'!$E$19:$E$23</c:f>
              <c:numCache>
                <c:formatCode>General</c:formatCode>
                <c:ptCount val="5"/>
                <c:pt idx="0">
                  <c:v>83</c:v>
                </c:pt>
                <c:pt idx="1">
                  <c:v>43</c:v>
                </c:pt>
                <c:pt idx="2">
                  <c:v>26</c:v>
                </c:pt>
                <c:pt idx="3">
                  <c:v>11</c:v>
                </c:pt>
                <c:pt idx="4">
                  <c:v>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B1C-489F-A44D-95E9D2F113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87090384"/>
        <c:axId val="80768096"/>
      </c:barChart>
      <c:catAx>
        <c:axId val="87090384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CO"/>
          </a:p>
        </c:txPr>
        <c:crossAx val="80768096"/>
        <c:crosses val="autoZero"/>
        <c:auto val="1"/>
        <c:lblAlgn val="ctr"/>
        <c:lblOffset val="100"/>
        <c:noMultiLvlLbl val="0"/>
      </c:catAx>
      <c:valAx>
        <c:axId val="80768096"/>
        <c:scaling>
          <c:orientation val="minMax"/>
          <c:max val="30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prstDash val="sysDot"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CO"/>
          </a:p>
        </c:txPr>
        <c:crossAx val="87090384"/>
        <c:crosses val="max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s-CO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bg1">
          <a:lumMod val="75000"/>
        </a:schemeClr>
      </a:solidFill>
    </a:ln>
    <a:effectLst/>
  </c:spPr>
  <c:txPr>
    <a:bodyPr/>
    <a:lstStyle/>
    <a:p>
      <a:pPr>
        <a:defRPr/>
      </a:pPr>
      <a:endParaRPr lang="es-CO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Min-Body medicine</a:t>
            </a:r>
          </a:p>
        </c:rich>
      </c:tx>
      <c:layout>
        <c:manualLayout>
          <c:xMode val="edge"/>
          <c:yMode val="edge"/>
          <c:x val="4.3573852366302929E-2"/>
          <c:y val="2.784222737819025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s-CO"/>
        </a:p>
      </c:txPr>
    </c:title>
    <c:autoTitleDeleted val="0"/>
    <c:plotArea>
      <c:layout/>
      <c:barChart>
        <c:barDir val="bar"/>
        <c:grouping val="stacked"/>
        <c:varyColors val="0"/>
        <c:ser>
          <c:idx val="0"/>
          <c:order val="0"/>
          <c:tx>
            <c:strRef>
              <c:f>'Figure 1'!$C$25</c:f>
              <c:strCache>
                <c:ptCount val="1"/>
                <c:pt idx="0">
                  <c:v>Curative</c:v>
                </c:pt>
              </c:strCache>
            </c:strRef>
          </c:tx>
          <c:spPr>
            <a:solidFill>
              <a:schemeClr val="accent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Figure 1'!$B$26:$B$30</c:f>
              <c:strCache>
                <c:ptCount val="5"/>
                <c:pt idx="0">
                  <c:v>Massage</c:v>
                </c:pt>
                <c:pt idx="1">
                  <c:v>Meditation</c:v>
                </c:pt>
                <c:pt idx="2">
                  <c:v>Pray</c:v>
                </c:pt>
                <c:pt idx="3">
                  <c:v>Yoga</c:v>
                </c:pt>
                <c:pt idx="4">
                  <c:v>Aromatherapy</c:v>
                </c:pt>
              </c:strCache>
            </c:strRef>
          </c:cat>
          <c:val>
            <c:numRef>
              <c:f>'Figure 1'!$C$26:$C$30</c:f>
              <c:numCache>
                <c:formatCode>General</c:formatCode>
                <c:ptCount val="5"/>
                <c:pt idx="0">
                  <c:v>16</c:v>
                </c:pt>
                <c:pt idx="1">
                  <c:v>14</c:v>
                </c:pt>
                <c:pt idx="2">
                  <c:v>16</c:v>
                </c:pt>
                <c:pt idx="3">
                  <c:v>0</c:v>
                </c:pt>
                <c:pt idx="4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F46-43BD-BB7F-3FF0FE895E1F}"/>
            </c:ext>
          </c:extLst>
        </c:ser>
        <c:ser>
          <c:idx val="1"/>
          <c:order val="1"/>
          <c:tx>
            <c:strRef>
              <c:f>'Figure 1'!$D$25</c:f>
              <c:strCache>
                <c:ptCount val="1"/>
                <c:pt idx="0">
                  <c:v>Both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cat>
            <c:strRef>
              <c:f>'Figure 1'!$B$26:$B$30</c:f>
              <c:strCache>
                <c:ptCount val="5"/>
                <c:pt idx="0">
                  <c:v>Massage</c:v>
                </c:pt>
                <c:pt idx="1">
                  <c:v>Meditation</c:v>
                </c:pt>
                <c:pt idx="2">
                  <c:v>Pray</c:v>
                </c:pt>
                <c:pt idx="3">
                  <c:v>Yoga</c:v>
                </c:pt>
                <c:pt idx="4">
                  <c:v>Aromatherapy</c:v>
                </c:pt>
              </c:strCache>
            </c:strRef>
          </c:cat>
          <c:val>
            <c:numRef>
              <c:f>'Figure 1'!$D$26:$D$30</c:f>
              <c:numCache>
                <c:formatCode>General</c:formatCode>
                <c:ptCount val="5"/>
                <c:pt idx="0">
                  <c:v>17</c:v>
                </c:pt>
                <c:pt idx="1">
                  <c:v>14</c:v>
                </c:pt>
                <c:pt idx="2">
                  <c:v>18</c:v>
                </c:pt>
                <c:pt idx="3">
                  <c:v>6</c:v>
                </c:pt>
                <c:pt idx="4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F46-43BD-BB7F-3FF0FE895E1F}"/>
            </c:ext>
          </c:extLst>
        </c:ser>
        <c:ser>
          <c:idx val="2"/>
          <c:order val="2"/>
          <c:tx>
            <c:strRef>
              <c:f>'Figure 1'!$E$25</c:f>
              <c:strCache>
                <c:ptCount val="1"/>
                <c:pt idx="0">
                  <c:v>Palliative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strRef>
              <c:f>'Figure 1'!$B$26:$B$30</c:f>
              <c:strCache>
                <c:ptCount val="5"/>
                <c:pt idx="0">
                  <c:v>Massage</c:v>
                </c:pt>
                <c:pt idx="1">
                  <c:v>Meditation</c:v>
                </c:pt>
                <c:pt idx="2">
                  <c:v>Pray</c:v>
                </c:pt>
                <c:pt idx="3">
                  <c:v>Yoga</c:v>
                </c:pt>
                <c:pt idx="4">
                  <c:v>Aromatherapy</c:v>
                </c:pt>
              </c:strCache>
            </c:strRef>
          </c:cat>
          <c:val>
            <c:numRef>
              <c:f>'Figure 1'!$E$26:$E$30</c:f>
              <c:numCache>
                <c:formatCode>General</c:formatCode>
                <c:ptCount val="5"/>
                <c:pt idx="0">
                  <c:v>27</c:v>
                </c:pt>
                <c:pt idx="1">
                  <c:v>25</c:v>
                </c:pt>
                <c:pt idx="2">
                  <c:v>20</c:v>
                </c:pt>
                <c:pt idx="3">
                  <c:v>14</c:v>
                </c:pt>
                <c:pt idx="4">
                  <c:v>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F46-43BD-BB7F-3FF0FE895E1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10933120"/>
        <c:axId val="197399120"/>
      </c:barChart>
      <c:catAx>
        <c:axId val="210933120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CO"/>
          </a:p>
        </c:txPr>
        <c:crossAx val="197399120"/>
        <c:crosses val="autoZero"/>
        <c:auto val="1"/>
        <c:lblAlgn val="ctr"/>
        <c:lblOffset val="100"/>
        <c:noMultiLvlLbl val="0"/>
      </c:catAx>
      <c:valAx>
        <c:axId val="197399120"/>
        <c:scaling>
          <c:orientation val="minMax"/>
          <c:max val="30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CO"/>
          </a:p>
        </c:txPr>
        <c:crossAx val="210933120"/>
        <c:crosses val="max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s-CO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bg1">
          <a:lumMod val="75000"/>
        </a:schemeClr>
      </a:solidFill>
    </a:ln>
    <a:effectLst/>
  </c:spPr>
  <c:txPr>
    <a:bodyPr/>
    <a:lstStyle/>
    <a:p>
      <a:pPr>
        <a:defRPr/>
      </a:pPr>
      <a:endParaRPr lang="es-CO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CA1AB-A0CC-4183-BBD8-F639706181EA}" type="datetimeFigureOut">
              <a:rPr lang="es-CO" smtClean="0"/>
              <a:t>5/06/2023</a:t>
            </a:fld>
            <a:endParaRPr lang="es-C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F5A00-9ECB-489F-8647-2809EE96F0B2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1505810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CA1AB-A0CC-4183-BBD8-F639706181EA}" type="datetimeFigureOut">
              <a:rPr lang="es-CO" smtClean="0"/>
              <a:t>5/06/2023</a:t>
            </a:fld>
            <a:endParaRPr lang="es-C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F5A00-9ECB-489F-8647-2809EE96F0B2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6387502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CA1AB-A0CC-4183-BBD8-F639706181EA}" type="datetimeFigureOut">
              <a:rPr lang="es-CO" smtClean="0"/>
              <a:t>5/06/2023</a:t>
            </a:fld>
            <a:endParaRPr lang="es-C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F5A00-9ECB-489F-8647-2809EE96F0B2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584126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CA1AB-A0CC-4183-BBD8-F639706181EA}" type="datetimeFigureOut">
              <a:rPr lang="es-CO" smtClean="0"/>
              <a:t>5/06/2023</a:t>
            </a:fld>
            <a:endParaRPr lang="es-C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F5A00-9ECB-489F-8647-2809EE96F0B2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3511067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CA1AB-A0CC-4183-BBD8-F639706181EA}" type="datetimeFigureOut">
              <a:rPr lang="es-CO" smtClean="0"/>
              <a:t>5/06/2023</a:t>
            </a:fld>
            <a:endParaRPr lang="es-C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F5A00-9ECB-489F-8647-2809EE96F0B2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7823648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CA1AB-A0CC-4183-BBD8-F639706181EA}" type="datetimeFigureOut">
              <a:rPr lang="es-CO" smtClean="0"/>
              <a:t>5/06/2023</a:t>
            </a:fld>
            <a:endParaRPr lang="es-C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F5A00-9ECB-489F-8647-2809EE96F0B2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41720480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CA1AB-A0CC-4183-BBD8-F639706181EA}" type="datetimeFigureOut">
              <a:rPr lang="es-CO" smtClean="0"/>
              <a:t>5/06/2023</a:t>
            </a:fld>
            <a:endParaRPr lang="es-CO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F5A00-9ECB-489F-8647-2809EE96F0B2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7175433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CA1AB-A0CC-4183-BBD8-F639706181EA}" type="datetimeFigureOut">
              <a:rPr lang="es-CO" smtClean="0"/>
              <a:t>5/06/2023</a:t>
            </a:fld>
            <a:endParaRPr lang="es-CO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F5A00-9ECB-489F-8647-2809EE96F0B2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0942211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CA1AB-A0CC-4183-BBD8-F639706181EA}" type="datetimeFigureOut">
              <a:rPr lang="es-CO" smtClean="0"/>
              <a:t>5/06/2023</a:t>
            </a:fld>
            <a:endParaRPr lang="es-CO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F5A00-9ECB-489F-8647-2809EE96F0B2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2799812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CA1AB-A0CC-4183-BBD8-F639706181EA}" type="datetimeFigureOut">
              <a:rPr lang="es-CO" smtClean="0"/>
              <a:t>5/06/2023</a:t>
            </a:fld>
            <a:endParaRPr lang="es-C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F5A00-9ECB-489F-8647-2809EE96F0B2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2320249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CA1AB-A0CC-4183-BBD8-F639706181EA}" type="datetimeFigureOut">
              <a:rPr lang="es-CO" smtClean="0"/>
              <a:t>5/06/2023</a:t>
            </a:fld>
            <a:endParaRPr lang="es-C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F5A00-9ECB-489F-8647-2809EE96F0B2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2649272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FCA1AB-A0CC-4183-BBD8-F639706181EA}" type="datetimeFigureOut">
              <a:rPr lang="es-CO" smtClean="0"/>
              <a:t>5/06/2023</a:t>
            </a:fld>
            <a:endParaRPr lang="es-C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2F5A00-9ECB-489F-8647-2809EE96F0B2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9628869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áfico 1">
            <a:extLst>
              <a:ext uri="{FF2B5EF4-FFF2-40B4-BE49-F238E27FC236}">
                <a16:creationId xmlns:a16="http://schemas.microsoft.com/office/drawing/2014/main" id="{CA1628A2-A801-473E-8038-70AA6507AFB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72007641"/>
              </p:ext>
            </p:extLst>
          </p:nvPr>
        </p:nvGraphicFramePr>
        <p:xfrm>
          <a:off x="3433871" y="1746785"/>
          <a:ext cx="3434400" cy="2109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Gráfico 3">
            <a:extLst>
              <a:ext uri="{FF2B5EF4-FFF2-40B4-BE49-F238E27FC236}">
                <a16:creationId xmlns:a16="http://schemas.microsoft.com/office/drawing/2014/main" id="{8B5C94A8-BE4D-4009-B8F0-15BE5D0830E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47530416"/>
              </p:ext>
            </p:extLst>
          </p:nvPr>
        </p:nvGraphicFramePr>
        <p:xfrm>
          <a:off x="0" y="1748411"/>
          <a:ext cx="3434400" cy="2109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Gráfico 4">
            <a:extLst>
              <a:ext uri="{FF2B5EF4-FFF2-40B4-BE49-F238E27FC236}">
                <a16:creationId xmlns:a16="http://schemas.microsoft.com/office/drawing/2014/main" id="{817CCFB5-0FB7-4E8B-9CC1-34B10368C09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71909196"/>
              </p:ext>
            </p:extLst>
          </p:nvPr>
        </p:nvGraphicFramePr>
        <p:xfrm>
          <a:off x="3423600" y="6077010"/>
          <a:ext cx="3434400" cy="2109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" name="Gráfico 5">
            <a:extLst>
              <a:ext uri="{FF2B5EF4-FFF2-40B4-BE49-F238E27FC236}">
                <a16:creationId xmlns:a16="http://schemas.microsoft.com/office/drawing/2014/main" id="{091C705C-430F-4645-87C1-AEE85DA3C8C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15374918"/>
              </p:ext>
            </p:extLst>
          </p:nvPr>
        </p:nvGraphicFramePr>
        <p:xfrm>
          <a:off x="3424125" y="3908086"/>
          <a:ext cx="3434400" cy="2109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7" name="Gráfico 6">
            <a:extLst>
              <a:ext uri="{FF2B5EF4-FFF2-40B4-BE49-F238E27FC236}">
                <a16:creationId xmlns:a16="http://schemas.microsoft.com/office/drawing/2014/main" id="{856EE34F-CD99-4A4B-8A2C-733E7F1909E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12208844"/>
              </p:ext>
            </p:extLst>
          </p:nvPr>
        </p:nvGraphicFramePr>
        <p:xfrm>
          <a:off x="0" y="3907815"/>
          <a:ext cx="3434400" cy="2109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8" name="Gráfico 7">
            <a:extLst>
              <a:ext uri="{FF2B5EF4-FFF2-40B4-BE49-F238E27FC236}">
                <a16:creationId xmlns:a16="http://schemas.microsoft.com/office/drawing/2014/main" id="{2DEA7FAF-7B04-4F0A-81A5-051D98253EF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89867172"/>
              </p:ext>
            </p:extLst>
          </p:nvPr>
        </p:nvGraphicFramePr>
        <p:xfrm>
          <a:off x="0" y="6077010"/>
          <a:ext cx="3434400" cy="2109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3" name="CuadroTexto 2">
            <a:extLst>
              <a:ext uri="{FF2B5EF4-FFF2-40B4-BE49-F238E27FC236}">
                <a16:creationId xmlns:a16="http://schemas.microsoft.com/office/drawing/2014/main" id="{E65C6837-3F9B-468B-B491-883979A4566F}"/>
              </a:ext>
            </a:extLst>
          </p:cNvPr>
          <p:cNvSpPr txBox="1"/>
          <p:nvPr/>
        </p:nvSpPr>
        <p:spPr>
          <a:xfrm>
            <a:off x="397565" y="957390"/>
            <a:ext cx="580222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Supplementary</a:t>
            </a:r>
            <a:r>
              <a:rPr lang="es-ES" dirty="0"/>
              <a:t> file 2. F</a:t>
            </a:r>
            <a:r>
              <a:rPr lang="en-US" dirty="0" err="1"/>
              <a:t>ive</a:t>
            </a:r>
            <a:r>
              <a:rPr lang="en-US" dirty="0"/>
              <a:t> most common products by CAM</a:t>
            </a:r>
          </a:p>
          <a:p>
            <a:r>
              <a:rPr lang="en-US" dirty="0"/>
              <a:t>category in the study (number of patients)</a:t>
            </a:r>
            <a:endParaRPr lang="es-CO" dirty="0"/>
          </a:p>
          <a:p>
            <a:endParaRPr lang="es-CO" dirty="0"/>
          </a:p>
        </p:txBody>
      </p:sp>
    </p:spTree>
    <p:extLst>
      <p:ext uri="{BB962C8B-B14F-4D97-AF65-F5344CB8AC3E}">
        <p14:creationId xmlns:p14="http://schemas.microsoft.com/office/powerpoint/2010/main" val="348718767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1</TotalTime>
  <Words>33</Words>
  <Application>Microsoft Office PowerPoint</Application>
  <PresentationFormat>Presentación en pantalla (4:3)</PresentationFormat>
  <Paragraphs>8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Raul Hernando Murillo Moreno</dc:creator>
  <cp:lastModifiedBy>Raul Hernando Murillo Moreno</cp:lastModifiedBy>
  <cp:revision>2</cp:revision>
  <dcterms:created xsi:type="dcterms:W3CDTF">2023-06-05T09:45:41Z</dcterms:created>
  <dcterms:modified xsi:type="dcterms:W3CDTF">2023-06-05T10:47:17Z</dcterms:modified>
</cp:coreProperties>
</file>